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199313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2333" y="-6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649770"/>
            <a:ext cx="6119416" cy="3509551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5294662"/>
            <a:ext cx="5399485" cy="2433817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6797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854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536700"/>
            <a:ext cx="1552352" cy="854286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536700"/>
            <a:ext cx="4567064" cy="854286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4645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041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513159"/>
            <a:ext cx="6209407" cy="4193259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6746088"/>
            <a:ext cx="6209407" cy="2205136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2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683500"/>
            <a:ext cx="3059708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683500"/>
            <a:ext cx="3059708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113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536702"/>
            <a:ext cx="6209407" cy="1948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471154"/>
            <a:ext cx="3045646" cy="121107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682228"/>
            <a:ext cx="3045646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471154"/>
            <a:ext cx="3060646" cy="121107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682228"/>
            <a:ext cx="3060646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5305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6360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37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672042"/>
            <a:ext cx="2321966" cy="235214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451426"/>
            <a:ext cx="3644652" cy="7163777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024188"/>
            <a:ext cx="2321966" cy="5602681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383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672042"/>
            <a:ext cx="2321966" cy="235214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451426"/>
            <a:ext cx="3644652" cy="7163777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024188"/>
            <a:ext cx="2321966" cy="5602681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355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536702"/>
            <a:ext cx="6209407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683500"/>
            <a:ext cx="6209407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9343248"/>
            <a:ext cx="1619845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E5FC0E-321B-47D1-A35D-B9CC176D8A0E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9343248"/>
            <a:ext cx="2429768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9343248"/>
            <a:ext cx="1619845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4876B6-D299-46F4-9B56-D2FE3A8C8F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6580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>
            <a:extLst>
              <a:ext uri="{FF2B5EF4-FFF2-40B4-BE49-F238E27FC236}">
                <a16:creationId xmlns:a16="http://schemas.microsoft.com/office/drawing/2014/main" id="{036A15F8-0748-3347-B37C-A5B10CDE8F08}"/>
              </a:ext>
            </a:extLst>
          </p:cNvPr>
          <p:cNvGrpSpPr/>
          <p:nvPr/>
        </p:nvGrpSpPr>
        <p:grpSpPr>
          <a:xfrm>
            <a:off x="729566" y="526296"/>
            <a:ext cx="5740180" cy="9028032"/>
            <a:chOff x="2866453" y="-1405786"/>
            <a:chExt cx="5740180" cy="9028032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E5BB36AE-C8EA-AB75-D47E-B9404B74E7F3}"/>
                </a:ext>
              </a:extLst>
            </p:cNvPr>
            <p:cNvGrpSpPr/>
            <p:nvPr/>
          </p:nvGrpSpPr>
          <p:grpSpPr>
            <a:xfrm>
              <a:off x="2887941" y="-1249960"/>
              <a:ext cx="5718692" cy="4332550"/>
              <a:chOff x="498702" y="321973"/>
              <a:chExt cx="5718692" cy="4332550"/>
            </a:xfrm>
          </p:grpSpPr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B4418258-B0A3-BC7F-1762-EABEE9FCABBF}"/>
                  </a:ext>
                </a:extLst>
              </p:cNvPr>
              <p:cNvSpPr txBox="1"/>
              <p:nvPr/>
            </p:nvSpPr>
            <p:spPr>
              <a:xfrm>
                <a:off x="2245468" y="321973"/>
                <a:ext cx="26479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anhattan distanc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4" name="组合 53">
                <a:extLst>
                  <a:ext uri="{FF2B5EF4-FFF2-40B4-BE49-F238E27FC236}">
                    <a16:creationId xmlns:a16="http://schemas.microsoft.com/office/drawing/2014/main" id="{6B96C0F0-8F80-5A1C-5180-BFFAED28E2E0}"/>
                  </a:ext>
                </a:extLst>
              </p:cNvPr>
              <p:cNvGrpSpPr/>
              <p:nvPr/>
            </p:nvGrpSpPr>
            <p:grpSpPr>
              <a:xfrm>
                <a:off x="498704" y="2031608"/>
                <a:ext cx="5718690" cy="1239328"/>
                <a:chOff x="498704" y="547132"/>
                <a:chExt cx="5718690" cy="1239328"/>
              </a:xfrm>
            </p:grpSpPr>
            <p:pic>
              <p:nvPicPr>
                <p:cNvPr id="63" name="图片 62" descr="图表, 散点图&#10;&#10;描述已自动生成">
                  <a:extLst>
                    <a:ext uri="{FF2B5EF4-FFF2-40B4-BE49-F238E27FC236}">
                      <a16:creationId xmlns:a16="http://schemas.microsoft.com/office/drawing/2014/main" id="{971B2DC8-752C-C1C7-D646-C006BFA63F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547132"/>
                  <a:ext cx="2647950" cy="1239328"/>
                </a:xfrm>
                <a:prstGeom prst="rect">
                  <a:avLst/>
                </a:prstGeom>
              </p:spPr>
            </p:pic>
            <p:pic>
              <p:nvPicPr>
                <p:cNvPr id="64" name="图片 63" descr="图表, 散点图&#10;&#10;描述已自动生成">
                  <a:extLst>
                    <a:ext uri="{FF2B5EF4-FFF2-40B4-BE49-F238E27FC236}">
                      <a16:creationId xmlns:a16="http://schemas.microsoft.com/office/drawing/2014/main" id="{6BD30A6F-8D1B-5B7E-AF60-925EA7DC3A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547132"/>
                  <a:ext cx="2647950" cy="1239328"/>
                </a:xfrm>
                <a:prstGeom prst="rect">
                  <a:avLst/>
                </a:prstGeom>
              </p:spPr>
            </p:pic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5A6E9F2C-2DDD-D956-353C-3FB72CABD7C6}"/>
                    </a:ext>
                  </a:extLst>
                </p:cNvPr>
                <p:cNvSpPr txBox="1"/>
                <p:nvPr/>
              </p:nvSpPr>
              <p:spPr>
                <a:xfrm rot="16200000">
                  <a:off x="-6348" y="1059072"/>
                  <a:ext cx="122554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02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5" name="组合 54">
                <a:extLst>
                  <a:ext uri="{FF2B5EF4-FFF2-40B4-BE49-F238E27FC236}">
                    <a16:creationId xmlns:a16="http://schemas.microsoft.com/office/drawing/2014/main" id="{26A439FA-C2CE-7039-2B3D-AB45B3C7F6A1}"/>
                  </a:ext>
                </a:extLst>
              </p:cNvPr>
              <p:cNvGrpSpPr/>
              <p:nvPr/>
            </p:nvGrpSpPr>
            <p:grpSpPr>
              <a:xfrm>
                <a:off x="498703" y="3415195"/>
                <a:ext cx="5718691" cy="1239328"/>
                <a:chOff x="498703" y="3478695"/>
                <a:chExt cx="5718691" cy="1239328"/>
              </a:xfrm>
            </p:grpSpPr>
            <p:pic>
              <p:nvPicPr>
                <p:cNvPr id="60" name="图片 59" descr="图表, 散点图&#10;&#10;描述已自动生成">
                  <a:extLst>
                    <a:ext uri="{FF2B5EF4-FFF2-40B4-BE49-F238E27FC236}">
                      <a16:creationId xmlns:a16="http://schemas.microsoft.com/office/drawing/2014/main" id="{B07CABA9-46C0-A363-0739-B2FEFF3BE6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3478695"/>
                  <a:ext cx="2647950" cy="1239328"/>
                </a:xfrm>
                <a:prstGeom prst="rect">
                  <a:avLst/>
                </a:prstGeom>
              </p:spPr>
            </p:pic>
            <p:pic>
              <p:nvPicPr>
                <p:cNvPr id="61" name="图片 60" descr="图表, 散点图&#10;&#10;描述已自动生成">
                  <a:extLst>
                    <a:ext uri="{FF2B5EF4-FFF2-40B4-BE49-F238E27FC236}">
                      <a16:creationId xmlns:a16="http://schemas.microsoft.com/office/drawing/2014/main" id="{3D08B4B0-6FF2-6CF0-6E87-CBC52A567C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3478695"/>
                  <a:ext cx="2647950" cy="1239328"/>
                </a:xfrm>
                <a:prstGeom prst="rect">
                  <a:avLst/>
                </a:prstGeom>
              </p:spPr>
            </p:pic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56230B79-E68F-B7F4-E432-255362B3C1C7}"/>
                    </a:ext>
                  </a:extLst>
                </p:cNvPr>
                <p:cNvSpPr txBox="1"/>
                <p:nvPr/>
              </p:nvSpPr>
              <p:spPr>
                <a:xfrm rot="16200000">
                  <a:off x="142718" y="3958885"/>
                  <a:ext cx="92741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6" name="组合 55">
                <a:extLst>
                  <a:ext uri="{FF2B5EF4-FFF2-40B4-BE49-F238E27FC236}">
                    <a16:creationId xmlns:a16="http://schemas.microsoft.com/office/drawing/2014/main" id="{6F3FCC69-84B8-53BB-7578-FB6A2D159A3A}"/>
                  </a:ext>
                </a:extLst>
              </p:cNvPr>
              <p:cNvGrpSpPr/>
              <p:nvPr/>
            </p:nvGrpSpPr>
            <p:grpSpPr>
              <a:xfrm>
                <a:off x="498702" y="635787"/>
                <a:ext cx="5718692" cy="1251562"/>
                <a:chOff x="498703" y="2000680"/>
                <a:chExt cx="5718692" cy="1251562"/>
              </a:xfrm>
            </p:grpSpPr>
            <p:pic>
              <p:nvPicPr>
                <p:cNvPr id="57" name="图片 56" descr="图表, 散点图&#10;&#10;描述已自动生成">
                  <a:extLst>
                    <a:ext uri="{FF2B5EF4-FFF2-40B4-BE49-F238E27FC236}">
                      <a16:creationId xmlns:a16="http://schemas.microsoft.com/office/drawing/2014/main" id="{A2221254-703F-4358-4302-75FA9781F5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2012913"/>
                  <a:ext cx="2647951" cy="1239329"/>
                </a:xfrm>
                <a:prstGeom prst="rect">
                  <a:avLst/>
                </a:prstGeom>
              </p:spPr>
            </p:pic>
            <p:pic>
              <p:nvPicPr>
                <p:cNvPr id="58" name="图片 57" descr="图表, 散点图&#10;&#10;描述已自动生成">
                  <a:extLst>
                    <a:ext uri="{FF2B5EF4-FFF2-40B4-BE49-F238E27FC236}">
                      <a16:creationId xmlns:a16="http://schemas.microsoft.com/office/drawing/2014/main" id="{1A135D37-2E2A-B65C-7470-42D43C3A48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2012913"/>
                  <a:ext cx="2647951" cy="1239329"/>
                </a:xfrm>
                <a:prstGeom prst="rect">
                  <a:avLst/>
                </a:prstGeom>
              </p:spPr>
            </p:pic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C45603B5-B6D7-C6F5-5817-613098424176}"/>
                    </a:ext>
                  </a:extLst>
                </p:cNvPr>
                <p:cNvSpPr txBox="1"/>
                <p:nvPr/>
              </p:nvSpPr>
              <p:spPr>
                <a:xfrm rot="16200000">
                  <a:off x="-13240" y="2512623"/>
                  <a:ext cx="123933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0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4FCDA754-D458-8D60-74A4-DC0B22A20785}"/>
                </a:ext>
              </a:extLst>
            </p:cNvPr>
            <p:cNvGrpSpPr/>
            <p:nvPr/>
          </p:nvGrpSpPr>
          <p:grpSpPr>
            <a:xfrm>
              <a:off x="2870607" y="3419167"/>
              <a:ext cx="5736026" cy="4203079"/>
              <a:chOff x="481369" y="5120673"/>
              <a:chExt cx="5736026" cy="4203079"/>
            </a:xfrm>
          </p:grpSpPr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76825EF3-CA6C-7551-C9E2-81A50C21761C}"/>
                  </a:ext>
                </a:extLst>
              </p:cNvPr>
              <p:cNvSpPr txBox="1"/>
              <p:nvPr/>
            </p:nvSpPr>
            <p:spPr>
              <a:xfrm>
                <a:off x="2245468" y="5120673"/>
                <a:ext cx="26479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uclidean distance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32799370-71B9-729B-3507-1F667C2F2031}"/>
                  </a:ext>
                </a:extLst>
              </p:cNvPr>
              <p:cNvGrpSpPr/>
              <p:nvPr/>
            </p:nvGrpSpPr>
            <p:grpSpPr>
              <a:xfrm>
                <a:off x="481369" y="6768984"/>
                <a:ext cx="5718692" cy="1261486"/>
                <a:chOff x="498703" y="5405479"/>
                <a:chExt cx="5718692" cy="1261486"/>
              </a:xfrm>
            </p:grpSpPr>
            <p:pic>
              <p:nvPicPr>
                <p:cNvPr id="50" name="图片 49" descr="图表, 散点图&#10;&#10;描述已自动生成">
                  <a:extLst>
                    <a:ext uri="{FF2B5EF4-FFF2-40B4-BE49-F238E27FC236}">
                      <a16:creationId xmlns:a16="http://schemas.microsoft.com/office/drawing/2014/main" id="{979AA86A-B203-67D2-472D-71F51EB156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5427637"/>
                  <a:ext cx="2647951" cy="1239328"/>
                </a:xfrm>
                <a:prstGeom prst="rect">
                  <a:avLst/>
                </a:prstGeom>
              </p:spPr>
            </p:pic>
            <p:pic>
              <p:nvPicPr>
                <p:cNvPr id="51" name="图片 50" descr="图表, 散点图&#10;&#10;描述已自动生成">
                  <a:extLst>
                    <a:ext uri="{FF2B5EF4-FFF2-40B4-BE49-F238E27FC236}">
                      <a16:creationId xmlns:a16="http://schemas.microsoft.com/office/drawing/2014/main" id="{4BDD90E5-2FA0-1037-2D10-1B0DA34A44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5427637"/>
                  <a:ext cx="2647951" cy="1239328"/>
                </a:xfrm>
                <a:prstGeom prst="rect">
                  <a:avLst/>
                </a:prstGeom>
              </p:spPr>
            </p:pic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17008DC8-F8FB-83D0-7204-802F83664542}"/>
                    </a:ext>
                  </a:extLst>
                </p:cNvPr>
                <p:cNvSpPr txBox="1"/>
                <p:nvPr/>
              </p:nvSpPr>
              <p:spPr>
                <a:xfrm rot="16200000">
                  <a:off x="-6349" y="5910531"/>
                  <a:ext cx="122554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02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6F99D019-0310-5A34-F1F7-5E40EDB77B03}"/>
                  </a:ext>
                </a:extLst>
              </p:cNvPr>
              <p:cNvGrpSpPr/>
              <p:nvPr/>
            </p:nvGrpSpPr>
            <p:grpSpPr>
              <a:xfrm>
                <a:off x="498703" y="8088138"/>
                <a:ext cx="5718692" cy="1235614"/>
                <a:chOff x="498703" y="8088138"/>
                <a:chExt cx="5718692" cy="1235614"/>
              </a:xfrm>
            </p:grpSpPr>
            <p:pic>
              <p:nvPicPr>
                <p:cNvPr id="47" name="图片 46" descr="图表, 散点图&#10;&#10;描述已自动生成">
                  <a:extLst>
                    <a:ext uri="{FF2B5EF4-FFF2-40B4-BE49-F238E27FC236}">
                      <a16:creationId xmlns:a16="http://schemas.microsoft.com/office/drawing/2014/main" id="{64618FC2-C013-14A0-CB38-32DD1F1FE9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8088138"/>
                  <a:ext cx="2647951" cy="1235614"/>
                </a:xfrm>
                <a:prstGeom prst="rect">
                  <a:avLst/>
                </a:prstGeom>
              </p:spPr>
            </p:pic>
            <p:pic>
              <p:nvPicPr>
                <p:cNvPr id="48" name="图片 47" descr="图表, 散点图&#10;&#10;描述已自动生成">
                  <a:extLst>
                    <a:ext uri="{FF2B5EF4-FFF2-40B4-BE49-F238E27FC236}">
                      <a16:creationId xmlns:a16="http://schemas.microsoft.com/office/drawing/2014/main" id="{FD5061D3-5D86-79BB-A729-5FD92DF486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8088138"/>
                  <a:ext cx="2647951" cy="1235614"/>
                </a:xfrm>
                <a:prstGeom prst="rect">
                  <a:avLst/>
                </a:prstGeom>
              </p:spPr>
            </p:pic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4EACE70D-A6DF-1842-C31C-E4871B7EA486}"/>
                    </a:ext>
                  </a:extLst>
                </p:cNvPr>
                <p:cNvSpPr txBox="1"/>
                <p:nvPr/>
              </p:nvSpPr>
              <p:spPr>
                <a:xfrm rot="16200000">
                  <a:off x="142718" y="8579171"/>
                  <a:ext cx="92741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" name="组合 42">
                <a:extLst>
                  <a:ext uri="{FF2B5EF4-FFF2-40B4-BE49-F238E27FC236}">
                    <a16:creationId xmlns:a16="http://schemas.microsoft.com/office/drawing/2014/main" id="{60096199-E37F-7A24-0619-6937159DF4ED}"/>
                  </a:ext>
                </a:extLst>
              </p:cNvPr>
              <p:cNvGrpSpPr/>
              <p:nvPr/>
            </p:nvGrpSpPr>
            <p:grpSpPr>
              <a:xfrm>
                <a:off x="498702" y="5459287"/>
                <a:ext cx="5718692" cy="1252029"/>
                <a:chOff x="498703" y="6737839"/>
                <a:chExt cx="5718692" cy="1252029"/>
              </a:xfrm>
            </p:grpSpPr>
            <p:pic>
              <p:nvPicPr>
                <p:cNvPr id="44" name="图片 43" descr="图表, 散点图&#10;&#10;描述已自动生成">
                  <a:extLst>
                    <a:ext uri="{FF2B5EF4-FFF2-40B4-BE49-F238E27FC236}">
                      <a16:creationId xmlns:a16="http://schemas.microsoft.com/office/drawing/2014/main" id="{01F2674E-0F21-C44B-51F4-B407060F2B9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69444" y="6750540"/>
                  <a:ext cx="2647951" cy="1239328"/>
                </a:xfrm>
                <a:prstGeom prst="rect">
                  <a:avLst/>
                </a:prstGeom>
              </p:spPr>
            </p:pic>
            <p:pic>
              <p:nvPicPr>
                <p:cNvPr id="45" name="图片 44" descr="图表, 散点图&#10;&#10;描述已自动生成">
                  <a:extLst>
                    <a:ext uri="{FF2B5EF4-FFF2-40B4-BE49-F238E27FC236}">
                      <a16:creationId xmlns:a16="http://schemas.microsoft.com/office/drawing/2014/main" id="{F538FDB4-224D-5C00-C9C2-6CCF3A1DBC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1050" y="6750540"/>
                  <a:ext cx="2647951" cy="1239328"/>
                </a:xfrm>
                <a:prstGeom prst="rect">
                  <a:avLst/>
                </a:prstGeom>
              </p:spPr>
            </p:pic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1374F467-D21A-D810-DB45-0BA5E26122DF}"/>
                    </a:ext>
                  </a:extLst>
                </p:cNvPr>
                <p:cNvSpPr txBox="1"/>
                <p:nvPr/>
              </p:nvSpPr>
              <p:spPr>
                <a:xfrm rot="16200000">
                  <a:off x="-13240" y="7249782"/>
                  <a:ext cx="123933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 = 0.01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4DC1E7A9-2C77-48D9-F6D3-59A486267905}"/>
                </a:ext>
              </a:extLst>
            </p:cNvPr>
            <p:cNvSpPr txBox="1"/>
            <p:nvPr/>
          </p:nvSpPr>
          <p:spPr>
            <a:xfrm>
              <a:off x="2866453" y="-140578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38FA8986-DFF4-1FA8-B350-A60D47B2AE7D}"/>
                </a:ext>
              </a:extLst>
            </p:cNvPr>
            <p:cNvSpPr txBox="1"/>
            <p:nvPr/>
          </p:nvSpPr>
          <p:spPr>
            <a:xfrm>
              <a:off x="2866453" y="330450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E33669D1-B905-49E7-B737-4DCEA7D519E4}"/>
              </a:ext>
            </a:extLst>
          </p:cNvPr>
          <p:cNvGrpSpPr/>
          <p:nvPr/>
        </p:nvGrpSpPr>
        <p:grpSpPr>
          <a:xfrm>
            <a:off x="1303020" y="1073405"/>
            <a:ext cx="361950" cy="153888"/>
            <a:chOff x="1303020" y="1073405"/>
            <a:chExt cx="361950" cy="153888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344CAC91-2553-14F4-33D7-E4998B62AAF7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BDA162E2-4B65-DA9A-5545-704DF9B654A2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C92538DD-40BB-D6AD-F490-ABC8EE1D9619}"/>
              </a:ext>
            </a:extLst>
          </p:cNvPr>
          <p:cNvGrpSpPr/>
          <p:nvPr/>
        </p:nvGrpSpPr>
        <p:grpSpPr>
          <a:xfrm>
            <a:off x="2585085" y="1072602"/>
            <a:ext cx="361950" cy="153888"/>
            <a:chOff x="1303020" y="1073405"/>
            <a:chExt cx="361950" cy="153888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410093A1-EEC9-5D3C-D209-4BE60571C550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03776925-8E28-3D8B-4AE6-B0FA197FAAA4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95F811CA-463F-417E-7120-8A9FEB1B570C}"/>
              </a:ext>
            </a:extLst>
          </p:cNvPr>
          <p:cNvGrpSpPr/>
          <p:nvPr/>
        </p:nvGrpSpPr>
        <p:grpSpPr>
          <a:xfrm>
            <a:off x="4098925" y="1072602"/>
            <a:ext cx="361950" cy="153888"/>
            <a:chOff x="1303020" y="1073405"/>
            <a:chExt cx="361950" cy="153888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9EB97A92-91DF-B099-335B-03BD6525F8AA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51838A5-EB86-D931-2F0A-0BE43A2B7FB9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C6AE7982-013E-CD52-0AA0-89B963E2FF2E}"/>
              </a:ext>
            </a:extLst>
          </p:cNvPr>
          <p:cNvGrpSpPr/>
          <p:nvPr/>
        </p:nvGrpSpPr>
        <p:grpSpPr>
          <a:xfrm>
            <a:off x="1258934" y="2458276"/>
            <a:ext cx="361950" cy="153888"/>
            <a:chOff x="1303020" y="1073405"/>
            <a:chExt cx="361950" cy="153888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2641CE20-812D-9F48-2175-2413D13F61E2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F92CD0A-C8B9-9389-90A3-0842AA3918CE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C1C267E3-D012-A0AA-EDBB-501117B66DEE}"/>
              </a:ext>
            </a:extLst>
          </p:cNvPr>
          <p:cNvGrpSpPr/>
          <p:nvPr/>
        </p:nvGrpSpPr>
        <p:grpSpPr>
          <a:xfrm>
            <a:off x="2540999" y="2457473"/>
            <a:ext cx="361950" cy="153888"/>
            <a:chOff x="1303020" y="1073405"/>
            <a:chExt cx="361950" cy="153888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DF0F3B2C-4B1E-D465-B202-63CC7C8938E4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4CE720E-4DA7-AA29-D745-3C1507DE22C4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92A9473C-A9D1-0995-72C9-BDE5D1EDB2E0}"/>
              </a:ext>
            </a:extLst>
          </p:cNvPr>
          <p:cNvGrpSpPr/>
          <p:nvPr/>
        </p:nvGrpSpPr>
        <p:grpSpPr>
          <a:xfrm>
            <a:off x="4054839" y="2457473"/>
            <a:ext cx="361950" cy="153888"/>
            <a:chOff x="1303020" y="1073405"/>
            <a:chExt cx="361950" cy="153888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D0DAAC2E-BCB3-56A3-DC23-147F3EA446FF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3EFB281-1FD8-578E-099D-7EBF62AF824D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635A52A2-18B7-B9FF-476D-50B3B379C388}"/>
              </a:ext>
            </a:extLst>
          </p:cNvPr>
          <p:cNvGrpSpPr/>
          <p:nvPr/>
        </p:nvGrpSpPr>
        <p:grpSpPr>
          <a:xfrm>
            <a:off x="1261474" y="3840607"/>
            <a:ext cx="361950" cy="153888"/>
            <a:chOff x="1303020" y="1073405"/>
            <a:chExt cx="361950" cy="153888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03E4334A-0B42-AE11-6062-3F293DB49931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7CB9FA2-0B0A-C7F4-3F84-6F02ED895CEA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51C9EA9E-0C75-E783-896C-027F2FF08417}"/>
              </a:ext>
            </a:extLst>
          </p:cNvPr>
          <p:cNvGrpSpPr/>
          <p:nvPr/>
        </p:nvGrpSpPr>
        <p:grpSpPr>
          <a:xfrm>
            <a:off x="2543539" y="3839804"/>
            <a:ext cx="361950" cy="153888"/>
            <a:chOff x="1303020" y="1073405"/>
            <a:chExt cx="361950" cy="153888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8A6277E9-CB22-6835-5B4D-0D6B058994A4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7A10E3C-DC39-A913-026E-6764E31EA3D1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AA3AFFD1-0792-698F-6FA1-B87E0CA1970B}"/>
              </a:ext>
            </a:extLst>
          </p:cNvPr>
          <p:cNvGrpSpPr/>
          <p:nvPr/>
        </p:nvGrpSpPr>
        <p:grpSpPr>
          <a:xfrm>
            <a:off x="4057379" y="3839804"/>
            <a:ext cx="361950" cy="153888"/>
            <a:chOff x="1303020" y="1073405"/>
            <a:chExt cx="361950" cy="153888"/>
          </a:xfrm>
        </p:grpSpPr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C5814EA1-A0C7-5D31-8CBB-CE7F3174BC46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B4EB9023-48D3-9575-5084-4F3350D20DD9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3B72D182-D507-8455-1FF8-277AF15FB09F}"/>
              </a:ext>
            </a:extLst>
          </p:cNvPr>
          <p:cNvGrpSpPr/>
          <p:nvPr/>
        </p:nvGrpSpPr>
        <p:grpSpPr>
          <a:xfrm>
            <a:off x="1297940" y="5769135"/>
            <a:ext cx="361950" cy="153888"/>
            <a:chOff x="1303020" y="1073405"/>
            <a:chExt cx="361950" cy="153888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FC41CF41-0A90-DA1E-886D-AFE0DAAF479D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D8041ED-5283-E4D1-43E6-966B492D6FE7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5078546B-27DA-070D-9381-B25F39ED6C1B}"/>
              </a:ext>
            </a:extLst>
          </p:cNvPr>
          <p:cNvGrpSpPr/>
          <p:nvPr/>
        </p:nvGrpSpPr>
        <p:grpSpPr>
          <a:xfrm>
            <a:off x="2580005" y="5768332"/>
            <a:ext cx="361950" cy="153888"/>
            <a:chOff x="1303020" y="1073405"/>
            <a:chExt cx="361950" cy="153888"/>
          </a:xfrm>
        </p:grpSpPr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211A408D-F6D0-3F61-9657-55DB45553A42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E04638AD-FC68-672B-5768-89DE8BF2C7ED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BD57BD72-860E-B173-0DEA-85F9A63985FD}"/>
              </a:ext>
            </a:extLst>
          </p:cNvPr>
          <p:cNvGrpSpPr/>
          <p:nvPr/>
        </p:nvGrpSpPr>
        <p:grpSpPr>
          <a:xfrm>
            <a:off x="4093845" y="5768332"/>
            <a:ext cx="361950" cy="153888"/>
            <a:chOff x="1303020" y="1073405"/>
            <a:chExt cx="361950" cy="153888"/>
          </a:xfrm>
        </p:grpSpPr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296363FD-8BBB-2BC8-828F-35A6D68D6418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AAE7F4D5-DCE1-B3E2-E7A8-C7F3DFFA2B04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CC410149-4955-158D-932F-AA5D72D0FB06}"/>
              </a:ext>
            </a:extLst>
          </p:cNvPr>
          <p:cNvGrpSpPr/>
          <p:nvPr/>
        </p:nvGrpSpPr>
        <p:grpSpPr>
          <a:xfrm>
            <a:off x="1284969" y="7087283"/>
            <a:ext cx="361950" cy="153888"/>
            <a:chOff x="1303020" y="1073405"/>
            <a:chExt cx="361950" cy="153888"/>
          </a:xfrm>
        </p:grpSpPr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B212630D-E280-697D-8843-90DF85453902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AF26F0EC-6ABF-8B68-CA31-B861D66F0EE3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AAA7CCE2-9F5A-F75B-B399-B85DF93103BB}"/>
              </a:ext>
            </a:extLst>
          </p:cNvPr>
          <p:cNvGrpSpPr/>
          <p:nvPr/>
        </p:nvGrpSpPr>
        <p:grpSpPr>
          <a:xfrm>
            <a:off x="2567034" y="7086480"/>
            <a:ext cx="361950" cy="153888"/>
            <a:chOff x="1303020" y="1073405"/>
            <a:chExt cx="361950" cy="153888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28D56446-EDDA-B041-7093-5C31EAE9262A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C81981DB-36C8-9824-0E05-593704F1EF58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9B60F27F-D006-C009-ED9C-E1AB307D79BD}"/>
              </a:ext>
            </a:extLst>
          </p:cNvPr>
          <p:cNvGrpSpPr/>
          <p:nvPr/>
        </p:nvGrpSpPr>
        <p:grpSpPr>
          <a:xfrm>
            <a:off x="4080874" y="7086480"/>
            <a:ext cx="361950" cy="153888"/>
            <a:chOff x="1303020" y="1073405"/>
            <a:chExt cx="361950" cy="153888"/>
          </a:xfrm>
        </p:grpSpPr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9E5D0F70-0867-9D18-B2DA-CA88D1A77393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9E9ECC1D-9740-8DE2-280D-BE3CB81E7812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BEE56613-44B5-2699-286E-622CF658D383}"/>
              </a:ext>
            </a:extLst>
          </p:cNvPr>
          <p:cNvGrpSpPr/>
          <p:nvPr/>
        </p:nvGrpSpPr>
        <p:grpSpPr>
          <a:xfrm>
            <a:off x="1292860" y="8385644"/>
            <a:ext cx="361950" cy="153888"/>
            <a:chOff x="1303020" y="1073405"/>
            <a:chExt cx="361950" cy="153888"/>
          </a:xfrm>
        </p:grpSpPr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3DB117FA-0F48-10E1-9382-16DB813F753B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88CB92F1-46C7-BA1C-C36E-FEDFB82B2114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1AC12F4D-F25A-91D5-097C-0155C26A9FF1}"/>
              </a:ext>
            </a:extLst>
          </p:cNvPr>
          <p:cNvGrpSpPr/>
          <p:nvPr/>
        </p:nvGrpSpPr>
        <p:grpSpPr>
          <a:xfrm>
            <a:off x="2574925" y="8384841"/>
            <a:ext cx="361950" cy="153888"/>
            <a:chOff x="1303020" y="1073405"/>
            <a:chExt cx="361950" cy="153888"/>
          </a:xfrm>
        </p:grpSpPr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0D68D1B5-DBA4-AEDC-42B2-F080D26534FA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8A8706BC-7720-EA08-F30F-9B482D1B6FE1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4B86B1E0-35E3-B751-1F14-6D5D50FD1C3F}"/>
              </a:ext>
            </a:extLst>
          </p:cNvPr>
          <p:cNvGrpSpPr/>
          <p:nvPr/>
        </p:nvGrpSpPr>
        <p:grpSpPr>
          <a:xfrm>
            <a:off x="4088765" y="8384841"/>
            <a:ext cx="361950" cy="153888"/>
            <a:chOff x="1303020" y="1073405"/>
            <a:chExt cx="361950" cy="153888"/>
          </a:xfrm>
        </p:grpSpPr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E9B8D985-E119-D7A6-37D2-877530AB5D3E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0D65CFF4-0D78-D74D-3757-0B87EA15E917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7A0C7051-E379-6A68-5F62-4D9D173156D4}"/>
              </a:ext>
            </a:extLst>
          </p:cNvPr>
          <p:cNvGrpSpPr/>
          <p:nvPr/>
        </p:nvGrpSpPr>
        <p:grpSpPr>
          <a:xfrm>
            <a:off x="5371465" y="8384841"/>
            <a:ext cx="361950" cy="153888"/>
            <a:chOff x="1303020" y="1073405"/>
            <a:chExt cx="361950" cy="153888"/>
          </a:xfrm>
        </p:grpSpPr>
        <p:sp>
          <p:nvSpPr>
            <p:cNvPr id="88" name="矩形 87">
              <a:extLst>
                <a:ext uri="{FF2B5EF4-FFF2-40B4-BE49-F238E27FC236}">
                  <a16:creationId xmlns:a16="http://schemas.microsoft.com/office/drawing/2014/main" id="{65097400-326D-3C50-7DE2-646519304A4F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AEE6BCCF-6284-07CC-A0DC-AF085B34DAB2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F1F430ED-81A5-393B-4C91-35E046590D52}"/>
              </a:ext>
            </a:extLst>
          </p:cNvPr>
          <p:cNvGrpSpPr/>
          <p:nvPr/>
        </p:nvGrpSpPr>
        <p:grpSpPr>
          <a:xfrm>
            <a:off x="5350510" y="7086480"/>
            <a:ext cx="361950" cy="153888"/>
            <a:chOff x="1303020" y="1073405"/>
            <a:chExt cx="361950" cy="153888"/>
          </a:xfrm>
        </p:grpSpPr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7ED2FECF-2024-FB89-7ECF-27AF07DDC23F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49B23D28-2803-0442-3E2D-3B6165D462A9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B3DBF527-421F-D757-0E00-981DF3A437DB}"/>
              </a:ext>
            </a:extLst>
          </p:cNvPr>
          <p:cNvGrpSpPr/>
          <p:nvPr/>
        </p:nvGrpSpPr>
        <p:grpSpPr>
          <a:xfrm>
            <a:off x="5371465" y="5768332"/>
            <a:ext cx="361950" cy="153888"/>
            <a:chOff x="1303020" y="1073405"/>
            <a:chExt cx="361950" cy="153888"/>
          </a:xfrm>
        </p:grpSpPr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A253726F-B9E8-961A-2A1C-F9086DDA49C1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5C07476C-1F20-6E87-F287-8175F716F2E3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01F557D2-6807-4BBA-81D7-A87817609BDC}"/>
              </a:ext>
            </a:extLst>
          </p:cNvPr>
          <p:cNvGrpSpPr/>
          <p:nvPr/>
        </p:nvGrpSpPr>
        <p:grpSpPr>
          <a:xfrm>
            <a:off x="5329555" y="3839804"/>
            <a:ext cx="361950" cy="153888"/>
            <a:chOff x="1303020" y="1073405"/>
            <a:chExt cx="361950" cy="153888"/>
          </a:xfrm>
        </p:grpSpPr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82706B20-4430-DFCE-0D4C-4036DF52260D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5EF4BE15-DCF8-AC5A-00CB-47FB250DE23C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D7273F96-4480-FA01-F7F4-907EEBE1DD0E}"/>
              </a:ext>
            </a:extLst>
          </p:cNvPr>
          <p:cNvGrpSpPr/>
          <p:nvPr/>
        </p:nvGrpSpPr>
        <p:grpSpPr>
          <a:xfrm>
            <a:off x="5329555" y="2457473"/>
            <a:ext cx="361950" cy="153888"/>
            <a:chOff x="1303020" y="1073405"/>
            <a:chExt cx="361950" cy="153888"/>
          </a:xfrm>
        </p:grpSpPr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AA4AE334-6069-59C0-8FE4-79CF5DE08E33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C70BE409-023A-A3DB-3E0E-7125AF07C40B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组合 101">
            <a:extLst>
              <a:ext uri="{FF2B5EF4-FFF2-40B4-BE49-F238E27FC236}">
                <a16:creationId xmlns:a16="http://schemas.microsoft.com/office/drawing/2014/main" id="{4CDE4E8F-3EE9-4C7D-ECA6-578A43D6D6B4}"/>
              </a:ext>
            </a:extLst>
          </p:cNvPr>
          <p:cNvGrpSpPr/>
          <p:nvPr/>
        </p:nvGrpSpPr>
        <p:grpSpPr>
          <a:xfrm>
            <a:off x="5371465" y="1072602"/>
            <a:ext cx="361950" cy="153888"/>
            <a:chOff x="1303020" y="1073405"/>
            <a:chExt cx="361950" cy="153888"/>
          </a:xfrm>
        </p:grpSpPr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C795C82A-2FE9-BE5B-3FAE-3B9C1025565B}"/>
                </a:ext>
              </a:extLst>
            </p:cNvPr>
            <p:cNvSpPr/>
            <p:nvPr/>
          </p:nvSpPr>
          <p:spPr>
            <a:xfrm>
              <a:off x="1413510" y="1127518"/>
              <a:ext cx="99060" cy="612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C2811323-D11E-0278-F7EC-8B4858FA046B}"/>
                </a:ext>
              </a:extLst>
            </p:cNvPr>
            <p:cNvSpPr txBox="1"/>
            <p:nvPr/>
          </p:nvSpPr>
          <p:spPr>
            <a:xfrm>
              <a:off x="1303020" y="1073405"/>
              <a:ext cx="36195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y = x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1079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96</Words>
  <Application>Microsoft Office PowerPoint</Application>
  <PresentationFormat>自定义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30:00Z</dcterms:created>
  <dcterms:modified xsi:type="dcterms:W3CDTF">2025-06-27T08:26:55Z</dcterms:modified>
</cp:coreProperties>
</file>